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424"/>
    <p:restoredTop sz="94554"/>
  </p:normalViewPr>
  <p:slideViewPr>
    <p:cSldViewPr snapToGrid="0" snapToObjects="1">
      <p:cViewPr varScale="1">
        <p:scale>
          <a:sx n="93" d="100"/>
          <a:sy n="93" d="100"/>
        </p:scale>
        <p:origin x="240" y="52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9BC341-B0E8-554C-888B-3252B3AB75C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440B327-93FA-A742-9A0A-881EBF87A27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B5DE251-8AC3-CF48-A39F-FB0F4E7398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6AE8EE-384D-D84E-8313-B0371CA5EAD2}" type="datetimeFigureOut">
              <a:rPr lang="en-US" smtClean="0"/>
              <a:pPr/>
              <a:t>10/30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014DE8F-57D3-5044-A7C7-43D7A72E3F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B46E1A7-C2FF-D64D-8F68-73E0BE97A7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3DE2D7-A1BD-BD4E-AF66-1635FDF808D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01858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7A758B-48E7-9140-B7E3-BC866C89659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54BCEB8-C75A-6745-94B3-F0FA6B94911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3F1DF0B-10A9-3C4E-BE5C-ED144EDC54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6AE8EE-384D-D84E-8313-B0371CA5EAD2}" type="datetimeFigureOut">
              <a:rPr lang="en-US" smtClean="0"/>
              <a:pPr/>
              <a:t>10/30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CC3322A-C63B-F245-A7C0-415DFD0074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7F925B0-FC8D-D546-A8B7-7067101483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3DE2D7-A1BD-BD4E-AF66-1635FDF808D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69871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37704E7-88FE-DD47-A99D-4E54CABF874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BFCBB0E-6425-2C4D-A850-A5DAE308A88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97893B0-0E11-134A-B59A-C536515961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6AE8EE-384D-D84E-8313-B0371CA5EAD2}" type="datetimeFigureOut">
              <a:rPr lang="en-US" smtClean="0"/>
              <a:pPr/>
              <a:t>10/30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5378C9A-F564-5A49-BCC7-758322AF55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2DAC181-B9DC-724D-A30C-1AE3904335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3DE2D7-A1BD-BD4E-AF66-1635FDF808D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95487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4CECDE6-8E21-2144-B85B-ACAF7E59788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5182158-8A64-5E4A-839B-55F251A76F2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20F4B87-7698-9F4F-9F9A-CB22F63F1D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6AE8EE-384D-D84E-8313-B0371CA5EAD2}" type="datetimeFigureOut">
              <a:rPr lang="en-US" smtClean="0"/>
              <a:pPr/>
              <a:t>10/30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4F8D756-9621-C54B-B432-89C8D3A4EC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245E459-3A60-DD4B-B52D-BD3BF5F4B5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3DE2D7-A1BD-BD4E-AF66-1635FDF808D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42715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DDC5BB-13FF-064B-B11D-EA4DFBA294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B2C3587-74ED-C142-936D-4A5538A28DE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54EC16C-9D25-904F-A37D-1E12F24A6D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6AE8EE-384D-D84E-8313-B0371CA5EAD2}" type="datetimeFigureOut">
              <a:rPr lang="en-US" smtClean="0"/>
              <a:pPr/>
              <a:t>10/30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CC92817-A168-C748-8EAE-F5CA481A4A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4B97372-0A36-5149-AEF6-97555F9B85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3DE2D7-A1BD-BD4E-AF66-1635FDF808D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16256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6E0A05-3220-FF4D-9569-F76DD5F430E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787F3A6-CC33-AF4A-BA1D-09197005269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C5DFB44-ADA9-F048-9563-481015724A9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8F99FBD-2543-0D4D-9FBD-CFA0115FCD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6AE8EE-384D-D84E-8313-B0371CA5EAD2}" type="datetimeFigureOut">
              <a:rPr lang="en-US" smtClean="0"/>
              <a:pPr/>
              <a:t>10/30/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80953E5-F693-894C-A1A1-9A253968D7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B46DDE9-9F2D-4C41-B2DC-7C5959C3BE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3DE2D7-A1BD-BD4E-AF66-1635FDF808D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67592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F0D116-92ED-4144-823E-588EA529893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00C7C0E-CFE0-F444-A84D-817B57AEBA0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6CB0688-8362-8C4F-980C-C5BDD1DEF49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578AA4B-9697-1541-B6D4-0D35768C99D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2E6D51B-0451-0941-A1C9-405ED4BCC37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B79A6FB-674E-D140-A18D-3D3769FB73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6AE8EE-384D-D84E-8313-B0371CA5EAD2}" type="datetimeFigureOut">
              <a:rPr lang="en-US" smtClean="0"/>
              <a:pPr/>
              <a:t>10/30/19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80EA154-75A9-9F4C-A783-780D2C40C8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FE37ADA-3375-DF40-849E-5DB0000BD1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3DE2D7-A1BD-BD4E-AF66-1635FDF808D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89310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35E492-9E12-C949-B80C-C7EF8D5B218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2D303F6-E54C-2740-96DD-FD6D3485B7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6AE8EE-384D-D84E-8313-B0371CA5EAD2}" type="datetimeFigureOut">
              <a:rPr lang="en-US" smtClean="0"/>
              <a:pPr/>
              <a:t>10/30/19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8CAAD54-722B-E24A-A7AD-079BB17803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3F8F09C-9E2A-D14F-B818-2B1E1AC957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3DE2D7-A1BD-BD4E-AF66-1635FDF808D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44932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E0EE5D0-648D-974A-8D1D-87261F63F0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6AE8EE-384D-D84E-8313-B0371CA5EAD2}" type="datetimeFigureOut">
              <a:rPr lang="en-US" smtClean="0"/>
              <a:pPr/>
              <a:t>10/30/19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4B25579-84BC-474E-85B8-EAD8AC97DB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9BFA04F-2778-2142-9EB4-233EEB1F0F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3DE2D7-A1BD-BD4E-AF66-1635FDF808D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74691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6AD916-8D03-7F4C-B145-4E3DA9078F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4B41653-73A0-DE48-ADE9-1A86F6120F4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4F19843-5B8E-DF49-837E-D0FD99F1B1D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114B9A8-2E32-B744-82A4-6C6FD97520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6AE8EE-384D-D84E-8313-B0371CA5EAD2}" type="datetimeFigureOut">
              <a:rPr lang="en-US" smtClean="0"/>
              <a:pPr/>
              <a:t>10/30/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D136BD6-4DE2-D242-A9C4-641FFEE5A8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1685152-49FA-294B-B135-8B2FB05569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3DE2D7-A1BD-BD4E-AF66-1635FDF808D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65227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D70BD3-8F8F-7E49-A3A5-90B3EB61EA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B702340-E5E4-7741-AB68-668C96B85EE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5D7D98B-40BF-674A-B402-0EA9B7DA955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8DA4363-4FA3-C446-A666-3FB4560883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6AE8EE-384D-D84E-8313-B0371CA5EAD2}" type="datetimeFigureOut">
              <a:rPr lang="en-US" smtClean="0"/>
              <a:pPr/>
              <a:t>10/30/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E0EAD54-8539-744B-BC91-E205078254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B2A119F-7480-544F-9E5C-C19F367D57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3DE2D7-A1BD-BD4E-AF66-1635FDF808D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53876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B476A73-813F-0C4E-8A90-553625A89C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F696871-64D0-AE49-80EB-7CB4C8AE2F1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48DD87F-0A5E-4144-AE3C-C0754BEE76E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6AE8EE-384D-D84E-8313-B0371CA5EAD2}" type="datetimeFigureOut">
              <a:rPr lang="en-US" smtClean="0"/>
              <a:pPr/>
              <a:t>10/30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896617B-8115-9244-8F84-AF3F74335C8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3D75B1E-EF77-A548-B7FD-514A598144D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3DE2D7-A1BD-BD4E-AF66-1635FDF808D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49446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F50B6F7F-8D21-F049-AF3F-84847A0F1D09}"/>
              </a:ext>
            </a:extLst>
          </p:cNvPr>
          <p:cNvSpPr txBox="1"/>
          <p:nvPr/>
        </p:nvSpPr>
        <p:spPr>
          <a:xfrm>
            <a:off x="2860334" y="4251221"/>
            <a:ext cx="34038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Times" pitchFamily="2" charset="0"/>
              </a:rPr>
              <a:t>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B22E79E-76E2-EC43-BB0D-6EC08D23F3B4}"/>
              </a:ext>
            </a:extLst>
          </p:cNvPr>
          <p:cNvSpPr txBox="1"/>
          <p:nvPr/>
        </p:nvSpPr>
        <p:spPr>
          <a:xfrm>
            <a:off x="203954" y="4930438"/>
            <a:ext cx="11744587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" pitchFamily="2" charset="0"/>
              </a:rPr>
              <a:t>Supplementary figure 2: </a:t>
            </a:r>
            <a:r>
              <a:rPr lang="en-US" sz="1400" dirty="0">
                <a:latin typeface="Times" pitchFamily="2" charset="0"/>
              </a:rPr>
              <a:t>Positional enrichment of known transcription factor in the promoter regions of the differentially expressed genes at T = 1 h in sorghum drought-tolerant lines (DR1 and DR2) are shown using (a) Arabidopsis TF database and (b) general eukaryote TF database. These analyses were done using the </a:t>
            </a:r>
            <a:r>
              <a:rPr lang="en-US" sz="1400" dirty="0" err="1">
                <a:latin typeface="Times" pitchFamily="2" charset="0"/>
              </a:rPr>
              <a:t>Centrimo</a:t>
            </a:r>
            <a:r>
              <a:rPr lang="en-US" sz="1400" dirty="0">
                <a:latin typeface="Times" pitchFamily="2" charset="0"/>
              </a:rPr>
              <a:t> tool from MEME suite. </a:t>
            </a:r>
            <a:endParaRPr lang="en-US" sz="1400" b="1" dirty="0">
              <a:latin typeface="Times" pitchFamily="2" charset="0"/>
            </a:endParaRP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E3D3071A-8604-5F45-8C61-03D25C3AC2D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15409"/>
          <a:stretch/>
        </p:blipFill>
        <p:spPr>
          <a:xfrm>
            <a:off x="139295" y="1087364"/>
            <a:ext cx="5782464" cy="2736492"/>
          </a:xfrm>
          <a:prstGeom prst="rect">
            <a:avLst/>
          </a:prstGeom>
        </p:spPr>
      </p:pic>
      <p:grpSp>
        <p:nvGrpSpPr>
          <p:cNvPr id="2" name="Group 1">
            <a:extLst>
              <a:ext uri="{FF2B5EF4-FFF2-40B4-BE49-F238E27FC236}">
                <a16:creationId xmlns:a16="http://schemas.microsoft.com/office/drawing/2014/main" id="{4EF53E78-66C4-0147-BCDC-CA26EB1553BD}"/>
              </a:ext>
            </a:extLst>
          </p:cNvPr>
          <p:cNvGrpSpPr/>
          <p:nvPr/>
        </p:nvGrpSpPr>
        <p:grpSpPr>
          <a:xfrm>
            <a:off x="775852" y="3762469"/>
            <a:ext cx="5217078" cy="520333"/>
            <a:chOff x="775852" y="3720904"/>
            <a:chExt cx="5217078" cy="520333"/>
          </a:xfrm>
        </p:grpSpPr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7184DE9D-3DD5-244B-89F4-1793CEBF508A}"/>
                </a:ext>
              </a:extLst>
            </p:cNvPr>
            <p:cNvSpPr txBox="1"/>
            <p:nvPr/>
          </p:nvSpPr>
          <p:spPr>
            <a:xfrm>
              <a:off x="775852" y="3720904"/>
              <a:ext cx="5757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-1000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E46371C4-5497-F84A-BD11-34030F9974D4}"/>
                </a:ext>
              </a:extLst>
            </p:cNvPr>
            <p:cNvSpPr txBox="1"/>
            <p:nvPr/>
          </p:nvSpPr>
          <p:spPr>
            <a:xfrm>
              <a:off x="1224137" y="3720904"/>
              <a:ext cx="4908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-900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521D4C32-E4E6-B84D-8F3C-55E5A62986EB}"/>
                </a:ext>
              </a:extLst>
            </p:cNvPr>
            <p:cNvSpPr txBox="1"/>
            <p:nvPr/>
          </p:nvSpPr>
          <p:spPr>
            <a:xfrm>
              <a:off x="1676401" y="3720904"/>
              <a:ext cx="4908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-800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DDE7C683-BD50-FC4A-B13C-752428206179}"/>
                </a:ext>
              </a:extLst>
            </p:cNvPr>
            <p:cNvSpPr txBox="1"/>
            <p:nvPr/>
          </p:nvSpPr>
          <p:spPr>
            <a:xfrm>
              <a:off x="2105891" y="3720904"/>
              <a:ext cx="4908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-700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63517570-65C1-2D4D-8CE8-72392D730D5B}"/>
                </a:ext>
              </a:extLst>
            </p:cNvPr>
            <p:cNvSpPr txBox="1"/>
            <p:nvPr/>
          </p:nvSpPr>
          <p:spPr>
            <a:xfrm>
              <a:off x="2549239" y="3720904"/>
              <a:ext cx="575799" cy="304699"/>
            </a:xfrm>
            <a:prstGeom prst="rect">
              <a:avLst/>
            </a:prstGeom>
            <a:noFill/>
          </p:spPr>
          <p:txBody>
            <a:bodyPr wrap="none" rtlCol="0">
              <a:no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-600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4CE7FA5C-FDE2-0047-B457-E0B35C550F3F}"/>
                </a:ext>
              </a:extLst>
            </p:cNvPr>
            <p:cNvSpPr txBox="1"/>
            <p:nvPr/>
          </p:nvSpPr>
          <p:spPr>
            <a:xfrm>
              <a:off x="3020286" y="3720904"/>
              <a:ext cx="4908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-500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7C973468-13A8-764F-ACE0-D61CC41EF6E0}"/>
                </a:ext>
              </a:extLst>
            </p:cNvPr>
            <p:cNvSpPr txBox="1"/>
            <p:nvPr/>
          </p:nvSpPr>
          <p:spPr>
            <a:xfrm>
              <a:off x="3551701" y="3720904"/>
              <a:ext cx="4908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-400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3F8D6374-586B-784C-865F-7E588D9CD857}"/>
                </a:ext>
              </a:extLst>
            </p:cNvPr>
            <p:cNvSpPr txBox="1"/>
            <p:nvPr/>
          </p:nvSpPr>
          <p:spPr>
            <a:xfrm>
              <a:off x="4003965" y="3720904"/>
              <a:ext cx="4908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-300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A5847FC9-D693-1042-96A0-277D4CB4DB66}"/>
                </a:ext>
              </a:extLst>
            </p:cNvPr>
            <p:cNvSpPr txBox="1"/>
            <p:nvPr/>
          </p:nvSpPr>
          <p:spPr>
            <a:xfrm>
              <a:off x="4433455" y="3720904"/>
              <a:ext cx="4908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-200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90CC6D9D-6D6F-0942-B936-0EF742860240}"/>
                </a:ext>
              </a:extLst>
            </p:cNvPr>
            <p:cNvSpPr txBox="1"/>
            <p:nvPr/>
          </p:nvSpPr>
          <p:spPr>
            <a:xfrm>
              <a:off x="4876803" y="3720904"/>
              <a:ext cx="575799" cy="304699"/>
            </a:xfrm>
            <a:prstGeom prst="rect">
              <a:avLst/>
            </a:prstGeom>
            <a:noFill/>
          </p:spPr>
          <p:txBody>
            <a:bodyPr wrap="none" rtlCol="0">
              <a:no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-100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232E1AC1-70CB-C447-AF44-110BA16E954C}"/>
                </a:ext>
              </a:extLst>
            </p:cNvPr>
            <p:cNvSpPr txBox="1"/>
            <p:nvPr/>
          </p:nvSpPr>
          <p:spPr>
            <a:xfrm>
              <a:off x="5417131" y="3720904"/>
              <a:ext cx="575799" cy="304699"/>
            </a:xfrm>
            <a:prstGeom prst="rect">
              <a:avLst/>
            </a:prstGeom>
            <a:noFill/>
          </p:spPr>
          <p:txBody>
            <a:bodyPr wrap="none" rtlCol="0">
              <a:no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-1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CAA57526-504A-4342-B026-CD1EFF507D59}"/>
                </a:ext>
              </a:extLst>
            </p:cNvPr>
            <p:cNvSpPr txBox="1"/>
            <p:nvPr/>
          </p:nvSpPr>
          <p:spPr>
            <a:xfrm>
              <a:off x="1891979" y="3948849"/>
              <a:ext cx="2735044" cy="292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300" dirty="0">
                  <a:latin typeface="Arial" panose="020B0604020202020204" pitchFamily="34" charset="0"/>
                  <a:cs typeface="Arial" panose="020B0604020202020204" pitchFamily="34" charset="0"/>
                </a:rPr>
                <a:t>Position of Best Site in Sequences</a:t>
              </a:r>
            </a:p>
          </p:txBody>
        </p:sp>
      </p:grpSp>
      <p:grpSp>
        <p:nvGrpSpPr>
          <p:cNvPr id="3" name="Group 2">
            <a:extLst>
              <a:ext uri="{FF2B5EF4-FFF2-40B4-BE49-F238E27FC236}">
                <a16:creationId xmlns:a16="http://schemas.microsoft.com/office/drawing/2014/main" id="{6E6BB729-F8A8-DA44-8755-615C18588F3C}"/>
              </a:ext>
            </a:extLst>
          </p:cNvPr>
          <p:cNvGrpSpPr/>
          <p:nvPr/>
        </p:nvGrpSpPr>
        <p:grpSpPr>
          <a:xfrm>
            <a:off x="6100047" y="1087363"/>
            <a:ext cx="5782464" cy="3574478"/>
            <a:chOff x="6100047" y="1087363"/>
            <a:chExt cx="5782464" cy="3574478"/>
          </a:xfrm>
        </p:grpSpPr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78B07EAE-557E-D844-8375-9133387C2D2A}"/>
                </a:ext>
              </a:extLst>
            </p:cNvPr>
            <p:cNvSpPr txBox="1"/>
            <p:nvPr/>
          </p:nvSpPr>
          <p:spPr>
            <a:xfrm>
              <a:off x="8991279" y="4261731"/>
              <a:ext cx="340389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b="1" dirty="0">
                  <a:latin typeface="Times" pitchFamily="2" charset="0"/>
                </a:rPr>
                <a:t>b</a:t>
              </a:r>
            </a:p>
          </p:txBody>
        </p:sp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0E1ACDC4-D119-C947-BB35-861122988C9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b="15408"/>
            <a:stretch/>
          </p:blipFill>
          <p:spPr>
            <a:xfrm>
              <a:off x="6100047" y="1087363"/>
              <a:ext cx="5782464" cy="2736493"/>
            </a:xfrm>
            <a:prstGeom prst="rect">
              <a:avLst/>
            </a:prstGeom>
          </p:spPr>
        </p:pic>
        <p:grpSp>
          <p:nvGrpSpPr>
            <p:cNvPr id="23" name="Group 22">
              <a:extLst>
                <a:ext uri="{FF2B5EF4-FFF2-40B4-BE49-F238E27FC236}">
                  <a16:creationId xmlns:a16="http://schemas.microsoft.com/office/drawing/2014/main" id="{DC438F2A-E803-3042-946E-6B3A974D6068}"/>
                </a:ext>
              </a:extLst>
            </p:cNvPr>
            <p:cNvGrpSpPr/>
            <p:nvPr/>
          </p:nvGrpSpPr>
          <p:grpSpPr>
            <a:xfrm>
              <a:off x="6648594" y="3752882"/>
              <a:ext cx="5217078" cy="520333"/>
              <a:chOff x="775852" y="3720904"/>
              <a:chExt cx="5217078" cy="520333"/>
            </a:xfrm>
          </p:grpSpPr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590F0E0B-87AA-7C40-96B5-6272F4FB5DDF}"/>
                  </a:ext>
                </a:extLst>
              </p:cNvPr>
              <p:cNvSpPr txBox="1"/>
              <p:nvPr/>
            </p:nvSpPr>
            <p:spPr>
              <a:xfrm>
                <a:off x="775852" y="3720904"/>
                <a:ext cx="57579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-1000</a:t>
                </a:r>
              </a:p>
            </p:txBody>
          </p: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303F2456-F099-E348-911B-82829E27E5BC}"/>
                  </a:ext>
                </a:extLst>
              </p:cNvPr>
              <p:cNvSpPr txBox="1"/>
              <p:nvPr/>
            </p:nvSpPr>
            <p:spPr>
              <a:xfrm>
                <a:off x="1224137" y="3720904"/>
                <a:ext cx="49084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-900</a:t>
                </a:r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C45D033C-8F3B-924E-B650-C3D22F120ADA}"/>
                  </a:ext>
                </a:extLst>
              </p:cNvPr>
              <p:cNvSpPr txBox="1"/>
              <p:nvPr/>
            </p:nvSpPr>
            <p:spPr>
              <a:xfrm>
                <a:off x="1676401" y="3720904"/>
                <a:ext cx="49084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-800</a:t>
                </a:r>
              </a:p>
            </p:txBody>
          </p: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74397563-D237-BF4E-B687-49E1F7AEB59F}"/>
                  </a:ext>
                </a:extLst>
              </p:cNvPr>
              <p:cNvSpPr txBox="1"/>
              <p:nvPr/>
            </p:nvSpPr>
            <p:spPr>
              <a:xfrm>
                <a:off x="2105891" y="3720904"/>
                <a:ext cx="49084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-700</a:t>
                </a:r>
              </a:p>
            </p:txBody>
          </p: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920A7DC8-B936-C14D-B150-FD8C2ECA94AD}"/>
                  </a:ext>
                </a:extLst>
              </p:cNvPr>
              <p:cNvSpPr txBox="1"/>
              <p:nvPr/>
            </p:nvSpPr>
            <p:spPr>
              <a:xfrm>
                <a:off x="2549239" y="3720904"/>
                <a:ext cx="575799" cy="304699"/>
              </a:xfrm>
              <a:prstGeom prst="rect">
                <a:avLst/>
              </a:prstGeom>
              <a:noFill/>
            </p:spPr>
            <p:txBody>
              <a:bodyPr wrap="none" rtlCol="0">
                <a:no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-600</a:t>
                </a:r>
              </a:p>
            </p:txBody>
          </p: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0F0DBC58-984E-494C-9666-7F0BB2F0E36E}"/>
                  </a:ext>
                </a:extLst>
              </p:cNvPr>
              <p:cNvSpPr txBox="1"/>
              <p:nvPr/>
            </p:nvSpPr>
            <p:spPr>
              <a:xfrm>
                <a:off x="3020286" y="3720904"/>
                <a:ext cx="49084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-500</a:t>
                </a:r>
              </a:p>
            </p:txBody>
          </p:sp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F184014A-D70C-874B-B970-2019F4C9B202}"/>
                  </a:ext>
                </a:extLst>
              </p:cNvPr>
              <p:cNvSpPr txBox="1"/>
              <p:nvPr/>
            </p:nvSpPr>
            <p:spPr>
              <a:xfrm>
                <a:off x="3551701" y="3720904"/>
                <a:ext cx="49084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-400</a:t>
                </a:r>
              </a:p>
            </p:txBody>
          </p:sp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5E609AA3-E620-F942-A170-584590CD0F9D}"/>
                  </a:ext>
                </a:extLst>
              </p:cNvPr>
              <p:cNvSpPr txBox="1"/>
              <p:nvPr/>
            </p:nvSpPr>
            <p:spPr>
              <a:xfrm>
                <a:off x="4003965" y="3720904"/>
                <a:ext cx="49084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-300</a:t>
                </a:r>
              </a:p>
            </p:txBody>
          </p:sp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4E15B14C-31EB-4D49-80B0-228B5B370F63}"/>
                  </a:ext>
                </a:extLst>
              </p:cNvPr>
              <p:cNvSpPr txBox="1"/>
              <p:nvPr/>
            </p:nvSpPr>
            <p:spPr>
              <a:xfrm>
                <a:off x="4433455" y="3720904"/>
                <a:ext cx="49084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-200</a:t>
                </a:r>
              </a:p>
            </p:txBody>
          </p:sp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6858D74E-EF07-6C45-96EE-31754E3BC0AD}"/>
                  </a:ext>
                </a:extLst>
              </p:cNvPr>
              <p:cNvSpPr txBox="1"/>
              <p:nvPr/>
            </p:nvSpPr>
            <p:spPr>
              <a:xfrm>
                <a:off x="4876803" y="3720904"/>
                <a:ext cx="575799" cy="304699"/>
              </a:xfrm>
              <a:prstGeom prst="rect">
                <a:avLst/>
              </a:prstGeom>
              <a:noFill/>
            </p:spPr>
            <p:txBody>
              <a:bodyPr wrap="none" rtlCol="0">
                <a:no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-100</a:t>
                </a:r>
              </a:p>
            </p:txBody>
          </p:sp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D16257F3-6212-AF48-81D5-455C4C031108}"/>
                  </a:ext>
                </a:extLst>
              </p:cNvPr>
              <p:cNvSpPr txBox="1"/>
              <p:nvPr/>
            </p:nvSpPr>
            <p:spPr>
              <a:xfrm>
                <a:off x="5417131" y="3720904"/>
                <a:ext cx="575799" cy="304699"/>
              </a:xfrm>
              <a:prstGeom prst="rect">
                <a:avLst/>
              </a:prstGeom>
              <a:noFill/>
            </p:spPr>
            <p:txBody>
              <a:bodyPr wrap="none" rtlCol="0">
                <a:no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-1</a:t>
                </a:r>
              </a:p>
            </p:txBody>
          </p: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4ED631EA-DC44-E546-8993-39189CE974E6}"/>
                  </a:ext>
                </a:extLst>
              </p:cNvPr>
              <p:cNvSpPr txBox="1"/>
              <p:nvPr/>
            </p:nvSpPr>
            <p:spPr>
              <a:xfrm>
                <a:off x="1891979" y="3948849"/>
                <a:ext cx="2735044" cy="2923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300" dirty="0">
                    <a:latin typeface="Arial" panose="020B0604020202020204" pitchFamily="34" charset="0"/>
                    <a:cs typeface="Arial" panose="020B0604020202020204" pitchFamily="34" charset="0"/>
                  </a:rPr>
                  <a:t>Position of Best Site in Sequences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5181283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52</TotalTime>
  <Words>121</Words>
  <Application>Microsoft Macintosh PowerPoint</Application>
  <PresentationFormat>Widescreen</PresentationFormat>
  <Paragraphs>2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Abdel-Ghany,Salah</cp:lastModifiedBy>
  <cp:revision>16</cp:revision>
  <dcterms:created xsi:type="dcterms:W3CDTF">2019-09-27T18:03:41Z</dcterms:created>
  <dcterms:modified xsi:type="dcterms:W3CDTF">2019-10-31T05:49:43Z</dcterms:modified>
</cp:coreProperties>
</file>